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7" r:id="rId3"/>
    <p:sldId id="270" r:id="rId4"/>
    <p:sldId id="271" r:id="rId5"/>
    <p:sldId id="27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72" userDrawn="1">
          <p15:clr>
            <a:srgbClr val="A4A3A4"/>
          </p15:clr>
        </p15:guide>
        <p15:guide id="2" pos="3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74" y="102"/>
      </p:cViewPr>
      <p:guideLst>
        <p:guide orient="horz" pos="672"/>
        <p:guide pos="3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5630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746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24467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65145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5656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86806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0519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7355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1453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1094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24927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C0B25E-9DE4-46E6-BD53-925646CB1EAF}" type="datetimeFigureOut">
              <a:rPr lang="en-CA" smtClean="0"/>
              <a:t>2023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495A8-8A72-4F6B-AAB6-129379234E2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9930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86428" y="805190"/>
            <a:ext cx="9877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: Prognostic factors for overall survival in patient who received only curative CRT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910522"/>
              </p:ext>
            </p:extLst>
          </p:nvPr>
        </p:nvGraphicFramePr>
        <p:xfrm>
          <a:off x="495300" y="1615603"/>
          <a:ext cx="4762500" cy="2942908"/>
        </p:xfrm>
        <a:graphic>
          <a:graphicData uri="http://schemas.openxmlformats.org/drawingml/2006/table">
            <a:tbl>
              <a:tblPr/>
              <a:tblGrid>
                <a:gridCol w="1752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0975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ivariate analysis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22097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gnostic factor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 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 (95% CI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 vs Fema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3 (1.10, 1.37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nown </a:t>
                      </a:r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lson</a:t>
                      </a:r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cor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=1 vs 0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2 (0.92, 1.36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T Prior to Treatment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 (0.78, 0.96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8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 of Diagnosis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 (0.98, 1.02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6334228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ome Quintil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uinti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 (0.94, 1.01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9511942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rality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7 (0.93, 1.24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9319039"/>
                  </a:ext>
                </a:extLst>
              </a:tr>
              <a:tr h="186055">
                <a:tc gridSpan="4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ltivariate analysis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871070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gnostic factor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 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 (95% CI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7383508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 vs Fema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1 (1.08, 1.34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723386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nown </a:t>
                      </a:r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lson</a:t>
                      </a:r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cor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=1 vs 0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6 (0.87, 1.30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4667300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T Prior to Treatment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0 (0.70, 0.93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7873754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 of Diagnosis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2 (0.99, 1.04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8767650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ome Quintil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uinti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8 (0.94, 1.01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322613"/>
                  </a:ext>
                </a:extLst>
              </a:tr>
              <a:tr h="13672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rality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7 (0.92, 1.24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7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66230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5129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19380" y="805190"/>
            <a:ext cx="9935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: Prognostic factors for overall survival in patient who received CRT +/- surgery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7236339"/>
              </p:ext>
            </p:extLst>
          </p:nvPr>
        </p:nvGraphicFramePr>
        <p:xfrm>
          <a:off x="495300" y="1475560"/>
          <a:ext cx="4762500" cy="3309938"/>
        </p:xfrm>
        <a:graphic>
          <a:graphicData uri="http://schemas.openxmlformats.org/drawingml/2006/table">
            <a:tbl>
              <a:tblPr/>
              <a:tblGrid>
                <a:gridCol w="1752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0975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ivariate analysis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22097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gnostic factor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 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 (95% CI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 vs Fema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2 (1.10, 1.35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nown </a:t>
                      </a:r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lson</a:t>
                      </a:r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cor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=1 vs 0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2 (1.01, 1.46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rgery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 (0.50, 0.68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T Prior to Treatment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 (0.78, 0.95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4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 of Diagnosis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 (0.98, 1.01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6334228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ome Quintil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uinti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 (0.94, 1.01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9511942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rality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3 (0.99, 1.30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9319039"/>
                  </a:ext>
                </a:extLst>
              </a:tr>
              <a:tr h="186055">
                <a:tc gridSpan="4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ltivariate analysis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871070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gnostic factor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 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 (95% CI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7383508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 vs Fema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0 (1.08, 1.33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723386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nown </a:t>
                      </a:r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lson</a:t>
                      </a:r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cor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=1 vs 0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2 (0.94, 1.35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4667300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rgery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0 (0.52, 0.70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1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2474993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T Prior to Treatment 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3 (0.72, 0.95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7873754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 of Diagnosis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1 (0.99, 1.04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8767650"/>
                  </a:ext>
                </a:extLst>
              </a:tr>
              <a:tr h="186055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ome Quintil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uintile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7 (0.94, 1.01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322613"/>
                  </a:ext>
                </a:extLst>
              </a:tr>
              <a:tr h="13672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rality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vs No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1 (0.97, 1.27)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66230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59510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19380" y="805190"/>
            <a:ext cx="9935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: Mediastinal biopsy utilization 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2227293"/>
              </p:ext>
            </p:extLst>
          </p:nvPr>
        </p:nvGraphicFramePr>
        <p:xfrm>
          <a:off x="495300" y="1346661"/>
          <a:ext cx="5905499" cy="320040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241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5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8520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8520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8520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46185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1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stinoscopy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US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ther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7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4 (41.3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4 (41.3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8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7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8 (40.4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8 (40.4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9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1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0 (41.0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0 (41.0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9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3 (34.2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3 (34.2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1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5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8 (35.2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 (4.1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3 (38.2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2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4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8 (32.6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 (13.9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2 (43.5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3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6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1 (36.3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(16.5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7 (49.1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4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2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 (34.3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 (18.9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0 (48.3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5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7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4 (32.6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 (24.9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5 (51.4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0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9 (29.1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6 (24.7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1 (48.4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6185"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5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1 (28.2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8 (31.2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CA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8 (52.9)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03" marR="3703" marT="370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948453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19380" y="805190"/>
            <a:ext cx="9935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: PET Utilization and Proportion form 2007-2017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C8FB116-2D73-952D-C483-8F1DF08C95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8662308"/>
              </p:ext>
            </p:extLst>
          </p:nvPr>
        </p:nvGraphicFramePr>
        <p:xfrm>
          <a:off x="495300" y="1385063"/>
          <a:ext cx="4033568" cy="3200403"/>
        </p:xfrm>
        <a:graphic>
          <a:graphicData uri="http://schemas.openxmlformats.org/drawingml/2006/table">
            <a:tbl>
              <a:tblPr firstRow="1" firstCol="1" bandRow="1"/>
              <a:tblGrid>
                <a:gridCol w="945311">
                  <a:extLst>
                    <a:ext uri="{9D8B030D-6E8A-4147-A177-3AD203B41FA5}">
                      <a16:colId xmlns:a16="http://schemas.microsoft.com/office/drawing/2014/main" val="2446163073"/>
                    </a:ext>
                  </a:extLst>
                </a:gridCol>
                <a:gridCol w="629729">
                  <a:extLst>
                    <a:ext uri="{9D8B030D-6E8A-4147-A177-3AD203B41FA5}">
                      <a16:colId xmlns:a16="http://schemas.microsoft.com/office/drawing/2014/main" val="691680238"/>
                    </a:ext>
                  </a:extLst>
                </a:gridCol>
                <a:gridCol w="1268083">
                  <a:extLst>
                    <a:ext uri="{9D8B030D-6E8A-4147-A177-3AD203B41FA5}">
                      <a16:colId xmlns:a16="http://schemas.microsoft.com/office/drawing/2014/main" val="2946135115"/>
                    </a:ext>
                  </a:extLst>
                </a:gridCol>
                <a:gridCol w="1190445">
                  <a:extLst>
                    <a:ext uri="{9D8B030D-6E8A-4147-A177-3AD203B41FA5}">
                      <a16:colId xmlns:a16="http://schemas.microsoft.com/office/drawing/2014/main" val="4025647281"/>
                    </a:ext>
                  </a:extLst>
                </a:gridCol>
              </a:tblGrid>
              <a:tr h="3668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ar of Diagnosi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T Prior to Treat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t-Treatment PE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1921042"/>
                  </a:ext>
                </a:extLst>
              </a:tr>
              <a:tr h="187407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5667605"/>
                  </a:ext>
                </a:extLst>
              </a:tr>
              <a:tr h="187407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8802631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3 (12.4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 (1.8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4166590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5 (52.7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 (2.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5756877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3 (58.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 (2.8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144458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8 (62.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 (2.4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0576955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7 (64.7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 (2.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513128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2 (71.4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 (2.4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8614097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3 (71.6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 (1.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7998403"/>
                  </a:ext>
                </a:extLst>
              </a:tr>
              <a:tr h="272308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0 (73.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 (2.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2630900"/>
                  </a:ext>
                </a:extLst>
              </a:tr>
              <a:tr h="280316"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3 (74.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 (2.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5157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78558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19380" y="805190"/>
            <a:ext cx="9935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: Effect of PET on Treatment Choice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C8FB116-2D73-952D-C483-8F1DF08C95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5358381"/>
              </p:ext>
            </p:extLst>
          </p:nvPr>
        </p:nvGraphicFramePr>
        <p:xfrm>
          <a:off x="495300" y="1454074"/>
          <a:ext cx="5327530" cy="2423538"/>
        </p:xfrm>
        <a:graphic>
          <a:graphicData uri="http://schemas.openxmlformats.org/drawingml/2006/table">
            <a:tbl>
              <a:tblPr firstRow="1" firstCol="1" bandRow="1"/>
              <a:tblGrid>
                <a:gridCol w="1357178">
                  <a:extLst>
                    <a:ext uri="{9D8B030D-6E8A-4147-A177-3AD203B41FA5}">
                      <a16:colId xmlns:a16="http://schemas.microsoft.com/office/drawing/2014/main" val="2446163073"/>
                    </a:ext>
                  </a:extLst>
                </a:gridCol>
                <a:gridCol w="1856880">
                  <a:extLst>
                    <a:ext uri="{9D8B030D-6E8A-4147-A177-3AD203B41FA5}">
                      <a16:colId xmlns:a16="http://schemas.microsoft.com/office/drawing/2014/main" val="2946135115"/>
                    </a:ext>
                  </a:extLst>
                </a:gridCol>
                <a:gridCol w="2113472">
                  <a:extLst>
                    <a:ext uri="{9D8B030D-6E8A-4147-A177-3AD203B41FA5}">
                      <a16:colId xmlns:a16="http://schemas.microsoft.com/office/drawing/2014/main" val="4025647281"/>
                    </a:ext>
                  </a:extLst>
                </a:gridCol>
              </a:tblGrid>
              <a:tr h="35470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atment Modalit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PET Prior to Treat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T Prior to Treatment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1921042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06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3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7783729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diotherap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701 (55.6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62 (61.3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5667605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emotherap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15 (43.2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41 (60.1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8802631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emoradiotherap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20 (17.6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1 (16.8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4166590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rge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84 (14.0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3 (30.8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5756877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 Least One Treatmen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768 (72.7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CA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20 (87.8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1444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02636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</TotalTime>
  <Words>743</Words>
  <Application>Microsoft Office PowerPoint</Application>
  <PresentationFormat>Widescreen</PresentationFormat>
  <Paragraphs>26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aig Beers</dc:creator>
  <cp:lastModifiedBy>Uzoamaka Anyanwu</cp:lastModifiedBy>
  <cp:revision>55</cp:revision>
  <dcterms:created xsi:type="dcterms:W3CDTF">2021-09-24T02:09:15Z</dcterms:created>
  <dcterms:modified xsi:type="dcterms:W3CDTF">2023-07-24T10:37:54Z</dcterms:modified>
</cp:coreProperties>
</file>